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80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2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FE7D0-D042-4D0E-B45D-65AD78FE2015}" type="datetimeFigureOut">
              <a:rPr lang="ko-KR" altLang="en-US" smtClean="0"/>
              <a:t>2023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63361-8E40-41B7-9B3F-BD77092F83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6574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FE7D0-D042-4D0E-B45D-65AD78FE2015}" type="datetimeFigureOut">
              <a:rPr lang="ko-KR" altLang="en-US" smtClean="0"/>
              <a:t>2023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63361-8E40-41B7-9B3F-BD77092F83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38284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FE7D0-D042-4D0E-B45D-65AD78FE2015}" type="datetimeFigureOut">
              <a:rPr lang="ko-KR" altLang="en-US" smtClean="0"/>
              <a:t>2023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63361-8E40-41B7-9B3F-BD77092F83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9311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FE7D0-D042-4D0E-B45D-65AD78FE2015}" type="datetimeFigureOut">
              <a:rPr lang="ko-KR" altLang="en-US" smtClean="0"/>
              <a:t>2023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63361-8E40-41B7-9B3F-BD77092F83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4696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FE7D0-D042-4D0E-B45D-65AD78FE2015}" type="datetimeFigureOut">
              <a:rPr lang="ko-KR" altLang="en-US" smtClean="0"/>
              <a:t>2023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63361-8E40-41B7-9B3F-BD77092F83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16266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FE7D0-D042-4D0E-B45D-65AD78FE2015}" type="datetimeFigureOut">
              <a:rPr lang="ko-KR" altLang="en-US" smtClean="0"/>
              <a:t>2023-04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63361-8E40-41B7-9B3F-BD77092F83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9468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FE7D0-D042-4D0E-B45D-65AD78FE2015}" type="datetimeFigureOut">
              <a:rPr lang="ko-KR" altLang="en-US" smtClean="0"/>
              <a:t>2023-04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63361-8E40-41B7-9B3F-BD77092F83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89228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FE7D0-D042-4D0E-B45D-65AD78FE2015}" type="datetimeFigureOut">
              <a:rPr lang="ko-KR" altLang="en-US" smtClean="0"/>
              <a:t>2023-04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63361-8E40-41B7-9B3F-BD77092F83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61599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FE7D0-D042-4D0E-B45D-65AD78FE2015}" type="datetimeFigureOut">
              <a:rPr lang="ko-KR" altLang="en-US" smtClean="0"/>
              <a:t>2023-04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63361-8E40-41B7-9B3F-BD77092F83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4539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FE7D0-D042-4D0E-B45D-65AD78FE2015}" type="datetimeFigureOut">
              <a:rPr lang="ko-KR" altLang="en-US" smtClean="0"/>
              <a:t>2023-04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63361-8E40-41B7-9B3F-BD77092F83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04295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FE7D0-D042-4D0E-B45D-65AD78FE2015}" type="datetimeFigureOut">
              <a:rPr lang="ko-KR" altLang="en-US" smtClean="0"/>
              <a:t>2023-04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763361-8E40-41B7-9B3F-BD77092F83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322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7FE7D0-D042-4D0E-B45D-65AD78FE2015}" type="datetimeFigureOut">
              <a:rPr lang="ko-KR" altLang="en-US" smtClean="0"/>
              <a:t>2023-04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763361-8E40-41B7-9B3F-BD77092F836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5877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4BA7174C-120B-086B-6B0E-48F98571F16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237" t="10716" r="20268" b="-1852"/>
          <a:stretch/>
        </p:blipFill>
        <p:spPr>
          <a:xfrm>
            <a:off x="1559167" y="1493635"/>
            <a:ext cx="3739666" cy="4963960"/>
          </a:xfrm>
          <a:prstGeom prst="rect">
            <a:avLst/>
          </a:prstGeom>
        </p:spPr>
      </p:pic>
      <p:sp>
        <p:nvSpPr>
          <p:cNvPr id="5" name="타원 4">
            <a:extLst>
              <a:ext uri="{FF2B5EF4-FFF2-40B4-BE49-F238E27FC236}">
                <a16:creationId xmlns:a16="http://schemas.microsoft.com/office/drawing/2014/main" id="{5E54480E-68BC-8F9C-A154-9B6DAC65F96C}"/>
              </a:ext>
            </a:extLst>
          </p:cNvPr>
          <p:cNvSpPr/>
          <p:nvPr/>
        </p:nvSpPr>
        <p:spPr>
          <a:xfrm>
            <a:off x="2669366" y="3802427"/>
            <a:ext cx="335091" cy="323732"/>
          </a:xfrm>
          <a:prstGeom prst="ellipse">
            <a:avLst/>
          </a:prstGeom>
          <a:noFill/>
          <a:ln w="381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타원 5">
            <a:extLst>
              <a:ext uri="{FF2B5EF4-FFF2-40B4-BE49-F238E27FC236}">
                <a16:creationId xmlns:a16="http://schemas.microsoft.com/office/drawing/2014/main" id="{3774F1EE-30D9-5C9F-385E-ECB58206EE22}"/>
              </a:ext>
            </a:extLst>
          </p:cNvPr>
          <p:cNvSpPr/>
          <p:nvPr/>
        </p:nvSpPr>
        <p:spPr>
          <a:xfrm>
            <a:off x="3457469" y="2887081"/>
            <a:ext cx="335091" cy="323732"/>
          </a:xfrm>
          <a:prstGeom prst="ellipse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BE12F08-70B1-F8F9-CB7B-3AC0E1D4F33B}"/>
              </a:ext>
            </a:extLst>
          </p:cNvPr>
          <p:cNvSpPr txBox="1"/>
          <p:nvPr/>
        </p:nvSpPr>
        <p:spPr>
          <a:xfrm>
            <a:off x="1559167" y="6571185"/>
            <a:ext cx="379660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>
                <a:latin typeface="Arial" panose="020B0604020202020204" pitchFamily="34" charset="0"/>
                <a:cs typeface="Arial" panose="020B0604020202020204" pitchFamily="34" charset="0"/>
              </a:rPr>
              <a:t>FigureS1. The weak and healthy parts of the rehydrated leaf. </a:t>
            </a:r>
          </a:p>
          <a:p>
            <a:r>
              <a:rPr lang="en-US" altLang="ko-KR" sz="1200">
                <a:latin typeface="Arial" panose="020B0604020202020204" pitchFamily="34" charset="0"/>
                <a:cs typeface="Arial" panose="020B0604020202020204" pitchFamily="34" charset="0"/>
              </a:rPr>
              <a:t>Red circle indicates the weak part of the rehydrated leaf while blue circle shows the healthy part of that. </a:t>
            </a:r>
            <a:endParaRPr lang="ko-KR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31150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3</TotalTime>
  <Words>32</Words>
  <Application>Microsoft Office PowerPoint</Application>
  <PresentationFormat>A4 용지(210x297mm)</PresentationFormat>
  <Paragraphs>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정 동훈</dc:creator>
  <cp:lastModifiedBy>정 동훈</cp:lastModifiedBy>
  <cp:revision>2</cp:revision>
  <dcterms:created xsi:type="dcterms:W3CDTF">2023-04-06T06:43:06Z</dcterms:created>
  <dcterms:modified xsi:type="dcterms:W3CDTF">2023-04-06T06:56:19Z</dcterms:modified>
</cp:coreProperties>
</file>